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9" r:id="rId1"/>
  </p:sldMasterIdLst>
  <p:notesMasterIdLst>
    <p:notesMasterId r:id="rId5"/>
  </p:notesMasterIdLst>
  <p:sldIdLst>
    <p:sldId id="260" r:id="rId2"/>
    <p:sldId id="262" r:id="rId3"/>
    <p:sldId id="263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47" autoAdjust="0"/>
    <p:restoredTop sz="94660"/>
  </p:normalViewPr>
  <p:slideViewPr>
    <p:cSldViewPr snapToGrid="0">
      <p:cViewPr varScale="1">
        <p:scale>
          <a:sx n="78" d="100"/>
          <a:sy n="78" d="100"/>
        </p:scale>
        <p:origin x="3510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5A7080-4937-4050-AF66-56A9607EEA98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5F6EA-DFDA-4107-8D77-201FB3AD941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190616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5F6EA-DFDA-4107-8D77-201FB3AD941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497260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5F6EA-DFDA-4107-8D77-201FB3AD9419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7140616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5F6EA-DFDA-4107-8D77-201FB3AD9419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25880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55535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71401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099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2837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68287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16553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8294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6037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575416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84388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9111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FAC7FB-BC4A-4756-81B8-AD88382DD5DE}" type="datetimeFigureOut">
              <a:rPr lang="es-ES" smtClean="0"/>
              <a:t>21/09/2020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DA41A-3571-4CB0-9091-F864FD4B94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57066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0" r:id="rId1"/>
    <p:sldLayoutId id="2147483711" r:id="rId2"/>
    <p:sldLayoutId id="2147483712" r:id="rId3"/>
    <p:sldLayoutId id="2147483713" r:id="rId4"/>
    <p:sldLayoutId id="2147483714" r:id="rId5"/>
    <p:sldLayoutId id="2147483715" r:id="rId6"/>
    <p:sldLayoutId id="2147483716" r:id="rId7"/>
    <p:sldLayoutId id="2147483717" r:id="rId8"/>
    <p:sldLayoutId id="2147483718" r:id="rId9"/>
    <p:sldLayoutId id="2147483719" r:id="rId10"/>
    <p:sldLayoutId id="2147483720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Tabla 17">
            <a:extLst>
              <a:ext uri="{FF2B5EF4-FFF2-40B4-BE49-F238E27FC236}">
                <a16:creationId xmlns:a16="http://schemas.microsoft.com/office/drawing/2014/main" id="{0A651E3C-3F85-4041-9F06-D61FE39B14A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24323805"/>
              </p:ext>
            </p:extLst>
          </p:nvPr>
        </p:nvGraphicFramePr>
        <p:xfrm>
          <a:off x="261847" y="489035"/>
          <a:ext cx="6502365" cy="897319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600">
                  <a:extLst>
                    <a:ext uri="{9D8B030D-6E8A-4147-A177-3AD203B41FA5}">
                      <a16:colId xmlns:a16="http://schemas.microsoft.com/office/drawing/2014/main" val="1130854485"/>
                    </a:ext>
                  </a:extLst>
                </a:gridCol>
                <a:gridCol w="2268180">
                  <a:extLst>
                    <a:ext uri="{9D8B030D-6E8A-4147-A177-3AD203B41FA5}">
                      <a16:colId xmlns:a16="http://schemas.microsoft.com/office/drawing/2014/main" val="702858112"/>
                    </a:ext>
                  </a:extLst>
                </a:gridCol>
                <a:gridCol w="3406585">
                  <a:extLst>
                    <a:ext uri="{9D8B030D-6E8A-4147-A177-3AD203B41FA5}">
                      <a16:colId xmlns:a16="http://schemas.microsoft.com/office/drawing/2014/main" val="1935063741"/>
                    </a:ext>
                  </a:extLst>
                </a:gridCol>
              </a:tblGrid>
              <a:tr h="169524"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1647247"/>
                  </a:ext>
                </a:extLst>
              </a:tr>
              <a:tr h="180635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PROPORTIONAL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-Go/</a:t>
                      </a:r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Me (%)</a:t>
                      </a:r>
                    </a:p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roportion existing between Sella (S) - Gonion (Go) distance and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nt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e) distanc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7592168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FH:AFH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Posterior Facial Height (PFH) to Anterior Facial Height (AFH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8184345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-Ar/Ar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posterior cranial base (S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to ramus height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9082727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ANS/(N-ANS+ANS-Me)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roportion of upper facial height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489230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Me:N-M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Lower Facial Height (LFH) to Total Facial Height (TFH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42037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ANS/ANS-Me (%)</a:t>
                      </a:r>
                      <a:endParaRPr lang="fr-F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tal Facial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Ratio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610045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/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M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roportion between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line and Gonion (Go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nt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e) line.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512168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/Me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maxillary length (ANS-PNS) to mandibular length (Me-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4489" marR="4489" marT="4489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977831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/SNB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Articular angle (S-R-Go) and SNB angle</a:t>
                      </a: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22891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Ar/ SNA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ella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-N-Ar) and SNA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194851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FH/MP-FH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lus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and mandibu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H)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871034"/>
                  </a:ext>
                </a:extLst>
              </a:tr>
              <a:tr h="17989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N/SN -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</a:p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endParaRPr lang="es-ES" sz="600" dirty="0"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lusal plane –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angle and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– Gonion (Go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plane angl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4409083"/>
                  </a:ext>
                </a:extLst>
              </a:tr>
              <a:tr h="18751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Palatal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/ SN -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</a:p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endParaRPr lang="es-ES" sz="600" dirty="0"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and palatal plane (ANS-PNS) angle and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- Gonion (Go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plane angl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394430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Anterior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N)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07497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/SN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NS-PNS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An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N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6461919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/Co-A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NS-PNS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A)</a:t>
                      </a: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5631530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NS-PNS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Base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7044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A)/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A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3527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od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od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3998615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A/Ar -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and point A (A) distanc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to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distanc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5285339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/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of 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28257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r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r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545043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12700">
                        <a:lnSpc>
                          <a:spcPct val="100000"/>
                        </a:lnSpc>
                        <a:spcBef>
                          <a:spcPts val="160"/>
                        </a:spcBef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-ANS) (%)</a:t>
                      </a: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osterior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 (S-Ar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-ANS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4143589"/>
                  </a:ext>
                </a:extLst>
              </a:tr>
              <a:tr h="187516">
                <a:tc rowSpan="3"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</a:p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r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NS-Me) (%)</a:t>
                      </a: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r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e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NS-Me) </a:t>
                      </a: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597495"/>
                  </a:ext>
                </a:extLst>
              </a:tr>
              <a:tr h="168987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N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.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-Na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%)</a:t>
                      </a: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N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nd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.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-Na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4608803"/>
                  </a:ext>
                </a:extLst>
              </a:tr>
              <a:tr h="176183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/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NB (%)</a:t>
                      </a: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Pg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dirty="0" err="1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int</a:t>
                      </a:r>
                      <a:r>
                        <a:rPr lang="es-ES" sz="600" dirty="0"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-point B (B) </a:t>
                      </a:r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ine distanc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6078398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067095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ANGUL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H - SN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Frankfort plane (FH) and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0052640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A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,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point A (A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943192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B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,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point B (B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034428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B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, point A (A) and point B (B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641056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D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,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point D (D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1957600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Y-Axis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plane and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4041767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and Gonion (Go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804619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Mx Base/SN-Palatal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 and palatal plane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061690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N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occlusal plane and 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390505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FH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lus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and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H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826924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Ba-Pt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 (Facial Axis-Ricketts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Ba) plane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terigoid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Pt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135575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P-FH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MA).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andibu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P) and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H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5821241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Xi-Pm (º) (Lower Face Height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anterior nasal spine (ANS), Xi point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uprapogon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Pm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99268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H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 (Facial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H) and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on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0442868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A-Pg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, point A (A) and 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8862063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acial Taper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mandibular plane and facial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7320900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-Me (º)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ni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/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Jaw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, Gonion (Go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nt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e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1046982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-Go-Na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 (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nial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, Gonion (Go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311637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-Go-Me (º) (Lower Gonial Angle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, Gonion (Go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nt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e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3509676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 Angle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Sella (S), 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and  Gonion (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1971624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Ar (º) (Saddle/Sella Angle)</a:t>
                      </a:r>
                      <a:endParaRPr lang="nb-NO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the Sella(S),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a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1958377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AB (º) (Sup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y  Sella (S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 plane and point A (A) - point B (B)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437367"/>
                  </a:ext>
                </a:extLst>
              </a:tr>
              <a:tr h="16952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p-FH (º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877" marR="3877" marT="3877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Rp) and Frankfort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FH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724" marR="3724" marT="3724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5571596"/>
                  </a:ext>
                </a:extLst>
              </a:tr>
            </a:tbl>
          </a:graphicData>
        </a:graphic>
      </p:graphicFrame>
      <p:grpSp>
        <p:nvGrpSpPr>
          <p:cNvPr id="13" name="Grupo 12">
            <a:extLst>
              <a:ext uri="{FF2B5EF4-FFF2-40B4-BE49-F238E27FC236}">
                <a16:creationId xmlns:a16="http://schemas.microsoft.com/office/drawing/2014/main" id="{0F21E75E-5269-4F86-8971-10FB59A4453C}"/>
              </a:ext>
            </a:extLst>
          </p:cNvPr>
          <p:cNvGrpSpPr/>
          <p:nvPr/>
        </p:nvGrpSpPr>
        <p:grpSpPr>
          <a:xfrm>
            <a:off x="266771" y="9484950"/>
            <a:ext cx="6502365" cy="230550"/>
            <a:chOff x="1316693" y="12508151"/>
            <a:chExt cx="6188213" cy="159948"/>
          </a:xfrm>
        </p:grpSpPr>
        <p:sp>
          <p:nvSpPr>
            <p:cNvPr id="4" name="object 67">
              <a:extLst>
                <a:ext uri="{FF2B5EF4-FFF2-40B4-BE49-F238E27FC236}">
                  <a16:creationId xmlns:a16="http://schemas.microsoft.com/office/drawing/2014/main" id="{98F0AEA7-46D5-4A80-BBFF-1FD970D626B2}"/>
                </a:ext>
              </a:extLst>
            </p:cNvPr>
            <p:cNvSpPr/>
            <p:nvPr/>
          </p:nvSpPr>
          <p:spPr>
            <a:xfrm>
              <a:off x="1316693" y="12547676"/>
              <a:ext cx="6188213" cy="112830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381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  <p:sp>
          <p:nvSpPr>
            <p:cNvPr id="5" name="object 66">
              <a:extLst>
                <a:ext uri="{FF2B5EF4-FFF2-40B4-BE49-F238E27FC236}">
                  <a16:creationId xmlns:a16="http://schemas.microsoft.com/office/drawing/2014/main" id="{DC7F9ECC-89EF-46A5-A9DB-3DC153D13774}"/>
                </a:ext>
              </a:extLst>
            </p:cNvPr>
            <p:cNvSpPr/>
            <p:nvPr/>
          </p:nvSpPr>
          <p:spPr>
            <a:xfrm>
              <a:off x="1316693" y="12508151"/>
              <a:ext cx="6188213" cy="159948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527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</p:grpSp>
      <p:sp>
        <p:nvSpPr>
          <p:cNvPr id="20" name="object 66">
            <a:extLst>
              <a:ext uri="{FF2B5EF4-FFF2-40B4-BE49-F238E27FC236}">
                <a16:creationId xmlns:a16="http://schemas.microsoft.com/office/drawing/2014/main" id="{0920120C-FD01-4D9C-9C66-1E85C85788A9}"/>
              </a:ext>
            </a:extLst>
          </p:cNvPr>
          <p:cNvSpPr/>
          <p:nvPr/>
        </p:nvSpPr>
        <p:spPr>
          <a:xfrm>
            <a:off x="261850" y="351609"/>
            <a:ext cx="6502365" cy="332730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21" name="object 67">
            <a:extLst>
              <a:ext uri="{FF2B5EF4-FFF2-40B4-BE49-F238E27FC236}">
                <a16:creationId xmlns:a16="http://schemas.microsoft.com/office/drawing/2014/main" id="{3F9B640A-685C-41D4-9880-BEA255A6A379}"/>
              </a:ext>
            </a:extLst>
          </p:cNvPr>
          <p:cNvSpPr/>
          <p:nvPr/>
        </p:nvSpPr>
        <p:spPr>
          <a:xfrm>
            <a:off x="261849" y="303632"/>
            <a:ext cx="6502365" cy="185403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/>
          </a:p>
        </p:txBody>
      </p:sp>
      <p:sp>
        <p:nvSpPr>
          <p:cNvPr id="14" name="object 2">
            <a:extLst>
              <a:ext uri="{FF2B5EF4-FFF2-40B4-BE49-F238E27FC236}">
                <a16:creationId xmlns:a16="http://schemas.microsoft.com/office/drawing/2014/main" id="{1B59BD54-21F7-4EB7-B958-8EF5E636991D}"/>
              </a:ext>
            </a:extLst>
          </p:cNvPr>
          <p:cNvSpPr txBox="1"/>
          <p:nvPr/>
        </p:nvSpPr>
        <p:spPr>
          <a:xfrm>
            <a:off x="267129" y="122479"/>
            <a:ext cx="4988858" cy="128400"/>
          </a:xfrm>
          <a:prstGeom prst="rect">
            <a:avLst/>
          </a:prstGeom>
        </p:spPr>
        <p:txBody>
          <a:bodyPr vert="horz" wrap="square" lIns="0" tIns="12858" rIns="0" bIns="0" rtlCol="0">
            <a:spAutoFit/>
          </a:bodyPr>
          <a:lstStyle/>
          <a:p>
            <a:pPr marL="9523">
              <a:spcBef>
                <a:spcPts val="101"/>
              </a:spcBef>
            </a:pPr>
            <a:r>
              <a:rPr lang="es-ES" sz="750" b="1" spc="12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2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2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 </a:t>
            </a:r>
            <a:r>
              <a:rPr lang="en-U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Explanation of cephalometric </a:t>
            </a:r>
            <a:r>
              <a:rPr lang="en-US" sz="750" b="1" spc="4" dirty="0" smtClean="0">
                <a:latin typeface="Helvetica World" panose="020B0500040000020004" pitchFamily="34" charset="0"/>
                <a:cs typeface="Helvetica World" panose="020B0500040000020004" pitchFamily="34" charset="0"/>
              </a:rPr>
              <a:t>measurements and abbreviations.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34319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0F21E75E-5269-4F86-8971-10FB59A4453C}"/>
              </a:ext>
            </a:extLst>
          </p:cNvPr>
          <p:cNvGrpSpPr/>
          <p:nvPr/>
        </p:nvGrpSpPr>
        <p:grpSpPr>
          <a:xfrm>
            <a:off x="261848" y="9654365"/>
            <a:ext cx="6502365" cy="230550"/>
            <a:chOff x="1316693" y="12508151"/>
            <a:chExt cx="6188213" cy="159948"/>
          </a:xfrm>
        </p:grpSpPr>
        <p:sp>
          <p:nvSpPr>
            <p:cNvPr id="4" name="object 67">
              <a:extLst>
                <a:ext uri="{FF2B5EF4-FFF2-40B4-BE49-F238E27FC236}">
                  <a16:creationId xmlns:a16="http://schemas.microsoft.com/office/drawing/2014/main" id="{98F0AEA7-46D5-4A80-BBFF-1FD970D626B2}"/>
                </a:ext>
              </a:extLst>
            </p:cNvPr>
            <p:cNvSpPr/>
            <p:nvPr/>
          </p:nvSpPr>
          <p:spPr>
            <a:xfrm>
              <a:off x="1316693" y="12547676"/>
              <a:ext cx="6188213" cy="112830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381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  <p:sp>
          <p:nvSpPr>
            <p:cNvPr id="5" name="object 66">
              <a:extLst>
                <a:ext uri="{FF2B5EF4-FFF2-40B4-BE49-F238E27FC236}">
                  <a16:creationId xmlns:a16="http://schemas.microsoft.com/office/drawing/2014/main" id="{DC7F9ECC-89EF-46A5-A9DB-3DC153D13774}"/>
                </a:ext>
              </a:extLst>
            </p:cNvPr>
            <p:cNvSpPr/>
            <p:nvPr/>
          </p:nvSpPr>
          <p:spPr>
            <a:xfrm>
              <a:off x="1316693" y="12508151"/>
              <a:ext cx="6188213" cy="159948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527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</p:grpSp>
      <p:sp>
        <p:nvSpPr>
          <p:cNvPr id="20" name="object 66">
            <a:extLst>
              <a:ext uri="{FF2B5EF4-FFF2-40B4-BE49-F238E27FC236}">
                <a16:creationId xmlns:a16="http://schemas.microsoft.com/office/drawing/2014/main" id="{0920120C-FD01-4D9C-9C66-1E85C85788A9}"/>
              </a:ext>
            </a:extLst>
          </p:cNvPr>
          <p:cNvSpPr/>
          <p:nvPr/>
        </p:nvSpPr>
        <p:spPr>
          <a:xfrm>
            <a:off x="261850" y="351609"/>
            <a:ext cx="6502365" cy="332730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21" name="object 67">
            <a:extLst>
              <a:ext uri="{FF2B5EF4-FFF2-40B4-BE49-F238E27FC236}">
                <a16:creationId xmlns:a16="http://schemas.microsoft.com/office/drawing/2014/main" id="{3F9B640A-685C-41D4-9880-BEA255A6A379}"/>
              </a:ext>
            </a:extLst>
          </p:cNvPr>
          <p:cNvSpPr/>
          <p:nvPr/>
        </p:nvSpPr>
        <p:spPr>
          <a:xfrm>
            <a:off x="261849" y="303632"/>
            <a:ext cx="6502365" cy="185403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/>
          </a:p>
        </p:txBody>
      </p:sp>
      <p:graphicFrame>
        <p:nvGraphicFramePr>
          <p:cNvPr id="9" name="Tabla 8">
            <a:extLst>
              <a:ext uri="{FF2B5EF4-FFF2-40B4-BE49-F238E27FC236}">
                <a16:creationId xmlns:a16="http://schemas.microsoft.com/office/drawing/2014/main" id="{5EF1F17D-EF0F-4282-A3D7-3712CD8D76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8018852"/>
              </p:ext>
            </p:extLst>
          </p:nvPr>
        </p:nvGraphicFramePr>
        <p:xfrm>
          <a:off x="261848" y="430889"/>
          <a:ext cx="6502365" cy="91176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598">
                  <a:extLst>
                    <a:ext uri="{9D8B030D-6E8A-4147-A177-3AD203B41FA5}">
                      <a16:colId xmlns:a16="http://schemas.microsoft.com/office/drawing/2014/main" val="1130854485"/>
                    </a:ext>
                  </a:extLst>
                </a:gridCol>
                <a:gridCol w="2253829">
                  <a:extLst>
                    <a:ext uri="{9D8B030D-6E8A-4147-A177-3AD203B41FA5}">
                      <a16:colId xmlns:a16="http://schemas.microsoft.com/office/drawing/2014/main" val="702858112"/>
                    </a:ext>
                  </a:extLst>
                </a:gridCol>
                <a:gridCol w="3420938">
                  <a:extLst>
                    <a:ext uri="{9D8B030D-6E8A-4147-A177-3AD203B41FA5}">
                      <a16:colId xmlns:a16="http://schemas.microsoft.com/office/drawing/2014/main" val="1935063741"/>
                    </a:ext>
                  </a:extLst>
                </a:gridCol>
              </a:tblGrid>
              <a:tr h="165108"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1647247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 LINE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 (mm) (Anterio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rani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Base) 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Sella (S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7592168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M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Anterior Face Height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ent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e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8184345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-ANS (mm) (Upper Face Height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and Anterior Nasal Spine (ANS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9082727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Me (mm) (Lower Face Height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Anterior Nasal Spine (ANS) and  Menton (Me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4892304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-Ar</a:t>
                      </a:r>
                      <a:r>
                        <a:rPr lang="pt-BR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Posterior Cranial Base)</a:t>
                      </a:r>
                      <a:endParaRPr lang="pt-BR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Sella (S) and Articulare (Ar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420373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Go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Posterior Face Height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Sella (S) and Gonion (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610045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mus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Articular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and Gonion (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512168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Go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dil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) and Gonion (Go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977831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A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mm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from point A (A) to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-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228914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-N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kelet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from point A (A) to the line perpendicular to Frankfort plane via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 perp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194851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A (mm)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idfac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dil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) and point A (A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871034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A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ticular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and point A (A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1440908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S-PNS (mm)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axillary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Anterior Nasal Spine (ANS) and Posterior Nasal Spine (PNS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7394430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NB (mm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 to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- point B (B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707497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-N Perp (mm) (Mand. Skeletal)</a:t>
                      </a:r>
                      <a:endParaRPr lang="da-DK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point B (B) to the line perpendicular to the Frankfort plane via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 perp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6461919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Mandibular Body Length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Gonion (Go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5631530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Length of Mand Base 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Gonion (Go) and 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87044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 (Mandibu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ength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Condilion (Co) and Gnation (Gn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603527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B1 Total mand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dil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) and point B (B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3998615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r - Gn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Articular point (Ar) and Gnation (Gn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5285339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asal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Width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orizontal distance of the symphysis at point B (B) level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28257"/>
                  </a:ext>
                </a:extLst>
              </a:tr>
              <a:tr h="276557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Co-A(mm)(Mx/Md diff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fference between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dil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) -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at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distance and th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dil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Co) - point A (A) distanc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5450434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Wits (FOP) (mm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point A and point B projected in the functional  occlusal plane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lusal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4143589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Wits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ppraisal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point A and point B projected in the occlusal plan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597495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0052640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ENTAL ANGUL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-L1 (º) (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Interincisal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upper incisor axisaxis (U1) and lower incisor axis(L1).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6943192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NA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upper incisor axis (U1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-point A (A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034428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SN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upper incisor axis (U1) and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oint(N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66410564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Palatal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upper incisor axis (U1) and the palatal plane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01957600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FH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the upper incisor axis (U1) and Frankfort plane (FH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4041767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NB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lower incisor axis (L1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-point B (B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4804619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A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lower incisor axis (L1) and point A (A)- 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6061690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FH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lower incisor axis (L1) and Frankfort plane (FH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1390505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-MP (º) (IMPA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lower incisor axis (L1) and mandibular plane.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8269246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6 long axis - MP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between first lower molar axis (L6) and mandibular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61355754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684" marR="2684" marT="2684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2578" marR="2578" marT="257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5821241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ENTAL LINE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verjet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orizontal distance between the incisal edge of the upper incisor (U1) and the lower incisor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(L1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099268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verbit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Vertical distance between the incisal edge of the upper incisor (U1) and the lower incisor (L1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10442868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NA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incisor (U1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-point A (A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886206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cclusal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incisor (U1) and occlusal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7320900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- PP (UADH)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incisor (U1) and palatal pla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1046982"/>
                  </a:ext>
                </a:extLst>
              </a:tr>
              <a:tr h="17762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l-PL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1 to Nasion Perp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incisor (U1) and the line perpendicular to Frankfort via the Nasion (N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8311637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NB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incisor (L1) and Nasion (N) - point B (B) l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350967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-APg (mm) (L1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rotrusion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incisor (L1) and  point A (A) - Pogonion (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61971624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to Occlusal Plane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incisor (L1) and occlusal pla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1958377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- MP (LADH)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incisor (L1) and mandibular pla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8437367"/>
                  </a:ext>
                </a:extLst>
              </a:tr>
              <a:tr h="277086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1 Tip - VRP (mm)</a:t>
                      </a: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incisor (U1) and perpendicular line to the vertical reference plane (VRP: plane built subtracting 7º from the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line passing through the Sella (S)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85571596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6 - PT Vertical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first upper molar (U6) and  vertical Pterigoyd line  (vertical PT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4798277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6 - PP (UPDH)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posterior dentoalveolar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eigh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.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rom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irs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molar (U6)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alatin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lan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7271823"/>
                  </a:ext>
                </a:extLst>
              </a:tr>
              <a:tr h="16510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6 - MP (LPDH)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posterior dentoalveolar height. Distance between first lower molar (L6) and palatal pla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6239217"/>
                  </a:ext>
                </a:extLst>
              </a:tr>
              <a:tr h="185758">
                <a:tc>
                  <a:txBody>
                    <a:bodyPr/>
                    <a:lstStyle/>
                    <a:p>
                      <a:pPr algn="l" fontAlgn="b"/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323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Molar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elation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  <a:p>
                      <a:pPr marL="0" marR="0" lvl="0" indent="0" algn="l" defTabSz="914323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distal surfaces of the first and second upper molar measured in the occlusal plane</a:t>
                      </a: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1540872"/>
                  </a:ext>
                </a:extLst>
              </a:tr>
            </a:tbl>
          </a:graphicData>
        </a:graphic>
      </p:graphicFrame>
      <p:sp>
        <p:nvSpPr>
          <p:cNvPr id="10" name="object 2">
            <a:extLst>
              <a:ext uri="{FF2B5EF4-FFF2-40B4-BE49-F238E27FC236}">
                <a16:creationId xmlns:a16="http://schemas.microsoft.com/office/drawing/2014/main" id="{4AE4B4CA-F8C7-4BD4-B722-1EBCE4663F59}"/>
              </a:ext>
            </a:extLst>
          </p:cNvPr>
          <p:cNvSpPr txBox="1"/>
          <p:nvPr/>
        </p:nvSpPr>
        <p:spPr>
          <a:xfrm>
            <a:off x="267129" y="122479"/>
            <a:ext cx="4988858" cy="128400"/>
          </a:xfrm>
          <a:prstGeom prst="rect">
            <a:avLst/>
          </a:prstGeom>
        </p:spPr>
        <p:txBody>
          <a:bodyPr vert="horz" wrap="square" lIns="0" tIns="12858" rIns="0" bIns="0" rtlCol="0">
            <a:spAutoFit/>
          </a:bodyPr>
          <a:lstStyle/>
          <a:p>
            <a:pPr marL="9523">
              <a:spcBef>
                <a:spcPts val="101"/>
              </a:spcBef>
            </a:pPr>
            <a:r>
              <a:rPr lang="es-ES" sz="750" b="1" spc="12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2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2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 </a:t>
            </a:r>
            <a:r>
              <a:rPr lang="en-U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Explanation of cephalometric measurements.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427904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o 12">
            <a:extLst>
              <a:ext uri="{FF2B5EF4-FFF2-40B4-BE49-F238E27FC236}">
                <a16:creationId xmlns:a16="http://schemas.microsoft.com/office/drawing/2014/main" id="{0F21E75E-5269-4F86-8971-10FB59A4453C}"/>
              </a:ext>
            </a:extLst>
          </p:cNvPr>
          <p:cNvGrpSpPr/>
          <p:nvPr/>
        </p:nvGrpSpPr>
        <p:grpSpPr>
          <a:xfrm>
            <a:off x="261848" y="7781495"/>
            <a:ext cx="6502365" cy="230550"/>
            <a:chOff x="1316693" y="12508151"/>
            <a:chExt cx="6188213" cy="159948"/>
          </a:xfrm>
        </p:grpSpPr>
        <p:sp>
          <p:nvSpPr>
            <p:cNvPr id="4" name="object 67">
              <a:extLst>
                <a:ext uri="{FF2B5EF4-FFF2-40B4-BE49-F238E27FC236}">
                  <a16:creationId xmlns:a16="http://schemas.microsoft.com/office/drawing/2014/main" id="{98F0AEA7-46D5-4A80-BBFF-1FD970D626B2}"/>
                </a:ext>
              </a:extLst>
            </p:cNvPr>
            <p:cNvSpPr/>
            <p:nvPr/>
          </p:nvSpPr>
          <p:spPr>
            <a:xfrm>
              <a:off x="1316693" y="12547676"/>
              <a:ext cx="6188213" cy="112830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381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  <p:sp>
          <p:nvSpPr>
            <p:cNvPr id="5" name="object 66">
              <a:extLst>
                <a:ext uri="{FF2B5EF4-FFF2-40B4-BE49-F238E27FC236}">
                  <a16:creationId xmlns:a16="http://schemas.microsoft.com/office/drawing/2014/main" id="{DC7F9ECC-89EF-46A5-A9DB-3DC153D13774}"/>
                </a:ext>
              </a:extLst>
            </p:cNvPr>
            <p:cNvSpPr/>
            <p:nvPr/>
          </p:nvSpPr>
          <p:spPr>
            <a:xfrm>
              <a:off x="1316693" y="12508151"/>
              <a:ext cx="6188213" cy="159948"/>
            </a:xfrm>
            <a:custGeom>
              <a:avLst/>
              <a:gdLst/>
              <a:ahLst/>
              <a:cxnLst/>
              <a:rect l="l" t="t" r="r" b="b"/>
              <a:pathLst>
                <a:path w="2099310">
                  <a:moveTo>
                    <a:pt x="0" y="0"/>
                  </a:moveTo>
                  <a:lnTo>
                    <a:pt x="2098934" y="0"/>
                  </a:lnTo>
                </a:path>
              </a:pathLst>
            </a:custGeom>
            <a:ln w="527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>
              <a:endParaRPr sz="1046"/>
            </a:p>
          </p:txBody>
        </p:sp>
      </p:grpSp>
      <p:sp>
        <p:nvSpPr>
          <p:cNvPr id="20" name="object 66">
            <a:extLst>
              <a:ext uri="{FF2B5EF4-FFF2-40B4-BE49-F238E27FC236}">
                <a16:creationId xmlns:a16="http://schemas.microsoft.com/office/drawing/2014/main" id="{0920120C-FD01-4D9C-9C66-1E85C85788A9}"/>
              </a:ext>
            </a:extLst>
          </p:cNvPr>
          <p:cNvSpPr/>
          <p:nvPr/>
        </p:nvSpPr>
        <p:spPr>
          <a:xfrm>
            <a:off x="261850" y="351609"/>
            <a:ext cx="6502365" cy="332730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527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  <p:sp>
        <p:nvSpPr>
          <p:cNvPr id="21" name="object 67">
            <a:extLst>
              <a:ext uri="{FF2B5EF4-FFF2-40B4-BE49-F238E27FC236}">
                <a16:creationId xmlns:a16="http://schemas.microsoft.com/office/drawing/2014/main" id="{3F9B640A-685C-41D4-9880-BEA255A6A379}"/>
              </a:ext>
            </a:extLst>
          </p:cNvPr>
          <p:cNvSpPr/>
          <p:nvPr/>
        </p:nvSpPr>
        <p:spPr>
          <a:xfrm>
            <a:off x="261849" y="303632"/>
            <a:ext cx="6502365" cy="185403"/>
          </a:xfrm>
          <a:custGeom>
            <a:avLst/>
            <a:gdLst/>
            <a:ahLst/>
            <a:cxnLst/>
            <a:rect l="l" t="t" r="r" b="b"/>
            <a:pathLst>
              <a:path w="2099310">
                <a:moveTo>
                  <a:pt x="0" y="0"/>
                </a:moveTo>
                <a:lnTo>
                  <a:pt x="2098934" y="0"/>
                </a:lnTo>
              </a:path>
            </a:pathLst>
          </a:custGeom>
          <a:ln w="38100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 sz="1951"/>
          </a:p>
        </p:txBody>
      </p:sp>
      <p:graphicFrame>
        <p:nvGraphicFramePr>
          <p:cNvPr id="11" name="Tabla 10">
            <a:extLst>
              <a:ext uri="{FF2B5EF4-FFF2-40B4-BE49-F238E27FC236}">
                <a16:creationId xmlns:a16="http://schemas.microsoft.com/office/drawing/2014/main" id="{4E95C62F-2FED-4BEB-87B9-BD00A92039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67450900"/>
              </p:ext>
            </p:extLst>
          </p:nvPr>
        </p:nvGraphicFramePr>
        <p:xfrm>
          <a:off x="261848" y="517974"/>
          <a:ext cx="6497086" cy="712011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6925">
                  <a:extLst>
                    <a:ext uri="{9D8B030D-6E8A-4147-A177-3AD203B41FA5}">
                      <a16:colId xmlns:a16="http://schemas.microsoft.com/office/drawing/2014/main" val="3135024101"/>
                    </a:ext>
                  </a:extLst>
                </a:gridCol>
                <a:gridCol w="2269257">
                  <a:extLst>
                    <a:ext uri="{9D8B030D-6E8A-4147-A177-3AD203B41FA5}">
                      <a16:colId xmlns:a16="http://schemas.microsoft.com/office/drawing/2014/main" val="3965834289"/>
                    </a:ext>
                  </a:extLst>
                </a:gridCol>
                <a:gridCol w="3400904">
                  <a:extLst>
                    <a:ext uri="{9D8B030D-6E8A-4147-A177-3AD203B41FA5}">
                      <a16:colId xmlns:a16="http://schemas.microsoft.com/office/drawing/2014/main" val="1346853225"/>
                    </a:ext>
                  </a:extLst>
                </a:gridCol>
              </a:tblGrid>
              <a:tr h="33545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ANGUL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LA (Nasal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(º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angle between columella (Cm),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ubnasal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n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abrale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superius (Ls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0816984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'-Sn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' (º) (Facial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Convexity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etwee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labella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G'),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ubnasa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Sn) and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on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')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73687482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'UL-Pg'N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' (º) (H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</a:t>
                      </a: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s-E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formed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etwee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on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')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ip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UL) line and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gon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g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') -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') lin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128940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3595053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0863000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LINE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 Lip - S Line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upper lip and S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6900763"/>
                  </a:ext>
                </a:extLst>
              </a:tr>
              <a:tr h="37662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ip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VRP (mm)</a:t>
                      </a: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endParaRPr lang="en-US" sz="600" u="none" strike="noStrike" dirty="0"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upper lip and the perpendicular line to the vertical reference plane (VRP: plane built subtracting 7º from the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line passing through the Sella (S)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6825756"/>
                  </a:ext>
                </a:extLst>
              </a:tr>
              <a:tr h="34702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N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Vert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erp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)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ip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upper lip and the perpendicular line to the Frankfort plane via the Nasion pointsoft (N'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1888362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Lip - S Line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lip and S line (esthetic plane of Steiner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1408480"/>
                  </a:ext>
                </a:extLst>
              </a:tr>
              <a:tr h="182105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 Lip to E-Plane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lip and E line (esthetic plane </a:t>
                      </a:r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f Ricketts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0148936"/>
                  </a:ext>
                </a:extLst>
              </a:tr>
              <a:tr h="37662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ip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- VRP (mm)</a:t>
                      </a: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lower lip and the perpendicular line to vertical reference plane  (VRP: plane built subtracting 7º from the Sella (S)-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) line passing through the Sella (S)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67484957"/>
                  </a:ext>
                </a:extLst>
              </a:tr>
              <a:tr h="34702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 N Vert (N Perp) to Lower Lip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lower lip and  perpendicular line to Frankfort plane via the soft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')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09571849"/>
                  </a:ext>
                </a:extLst>
              </a:tr>
              <a:tr h="347028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issue</a:t>
                      </a:r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N Vert (N Perp) to ST Pogonion (mm)</a:t>
                      </a:r>
                    </a:p>
                    <a:p>
                      <a:pPr algn="l" fontAlgn="b"/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Soft Pogonion (Pg') and perpendicular line to the palatal plane via the point Soft Nasion (N'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681087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'-Me'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Subnasale (Sn) and soft Menton (Me')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15385357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6281577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2224089"/>
                  </a:ext>
                </a:extLst>
              </a:tr>
              <a:tr h="33545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OFT TISSUE PROPORTIONS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'-sn'/sn'-me' (%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between Glabela (G') - Subnasale (Sn) line and Subnasale (Sn) -  soft Menton (Me') line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9314113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g'-sn'/sn'-gn' (%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between Glabela (G') - Subnasale (Sn) line and Subnasale (Sn) - soft Gnation (Gn') line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3964203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n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tomion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/ Sn-Me (%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Ratio between Subnasale (Sn) - Stomion line and Subnasale (Sn) - soft Menton (Me') li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9299144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76108343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80195096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 WAYS ANGULAR</a:t>
                      </a:r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OPT - NS (º)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gle formed between Odontoid line (OPT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Nasion</a:t>
                      </a:r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N') - Sella (S) line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8692361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7301695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164577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1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 WAY LINEAR</a:t>
                      </a:r>
                    </a:p>
                    <a:p>
                      <a:pPr algn="l" fontAlgn="b"/>
                      <a:endParaRPr lang="es-ES" sz="600" b="1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Lower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way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: Oro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haryngeal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point on the back contour of the soft palate and the nearest point on the pharyngeal wall.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89268852"/>
                  </a:ext>
                </a:extLst>
              </a:tr>
              <a:tr h="33545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Upper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irway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: Naso-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haryngeal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  <a:p>
                      <a:pPr algn="l" fontAlgn="b"/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point at the intersection of the rear edge of the tongue with the lower edge of the jaw and the nearest point of the rear pharyngeal wall.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96425871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Anterior nasal cavity height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the SNP and the nearest adenoid tissue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32166586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osterior nasal cavity height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Shortest distance between the base of the tongue and the posterior wall of the pharynx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7727374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H - PP (ANS-PNS)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Hyoid bone (H) and palatal plane</a:t>
                      </a:r>
                      <a:endParaRPr lang="en-US" sz="600" b="0" i="0" u="none" strike="noStrike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2295482"/>
                  </a:ext>
                </a:extLst>
              </a:tr>
              <a:tr h="192994"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 </a:t>
                      </a:r>
                      <a:endParaRPr lang="es-E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PNS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to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</a:t>
                      </a:r>
                      <a:r>
                        <a:rPr lang="es-ES" sz="6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asion</a:t>
                      </a:r>
                      <a:r>
                        <a:rPr lang="es-ES" sz="6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 (mm)</a:t>
                      </a: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u="none" strike="noStrike" dirty="0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Distance between Posterior Nasal Spine (PNS) and </a:t>
                      </a:r>
                      <a:r>
                        <a:rPr lang="en-US" sz="600" u="none" strike="noStrike" dirty="0" err="1">
                          <a:effectLst/>
                          <a:latin typeface="Helvetica World" panose="020B0500040000020004" pitchFamily="34" charset="0"/>
                          <a:cs typeface="Helvetica World" panose="020B0500040000020004" pitchFamily="34" charset="0"/>
                        </a:rPr>
                        <a:t>Basion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Helvetica World" panose="020B0500040000020004" pitchFamily="34" charset="0"/>
                        <a:cs typeface="Helvetica World" panose="020B0500040000020004" pitchFamily="34" charset="0"/>
                      </a:endParaRPr>
                    </a:p>
                  </a:txBody>
                  <a:tcPr marL="3108" marR="3108" marT="3108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8540233"/>
                  </a:ext>
                </a:extLst>
              </a:tr>
            </a:tbl>
          </a:graphicData>
        </a:graphic>
      </p:graphicFrame>
      <p:sp>
        <p:nvSpPr>
          <p:cNvPr id="9" name="object 2">
            <a:extLst>
              <a:ext uri="{FF2B5EF4-FFF2-40B4-BE49-F238E27FC236}">
                <a16:creationId xmlns:a16="http://schemas.microsoft.com/office/drawing/2014/main" id="{F02661E0-2E80-4AF3-8DA3-AAA2F3B925BE}"/>
              </a:ext>
            </a:extLst>
          </p:cNvPr>
          <p:cNvSpPr txBox="1"/>
          <p:nvPr/>
        </p:nvSpPr>
        <p:spPr>
          <a:xfrm>
            <a:off x="267129" y="122479"/>
            <a:ext cx="4988858" cy="128400"/>
          </a:xfrm>
          <a:prstGeom prst="rect">
            <a:avLst/>
          </a:prstGeom>
        </p:spPr>
        <p:txBody>
          <a:bodyPr vert="horz" wrap="square" lIns="0" tIns="12858" rIns="0" bIns="0" rtlCol="0">
            <a:spAutoFit/>
          </a:bodyPr>
          <a:lstStyle/>
          <a:p>
            <a:pPr marL="9523">
              <a:spcBef>
                <a:spcPts val="101"/>
              </a:spcBef>
            </a:pPr>
            <a:r>
              <a:rPr lang="es-ES" sz="750" b="1" spc="12" dirty="0" err="1">
                <a:latin typeface="Helvetica World" panose="020B0500040000020004" pitchFamily="34" charset="0"/>
                <a:cs typeface="Helvetica World" panose="020B0500040000020004" pitchFamily="34" charset="0"/>
              </a:rPr>
              <a:t>Supplementary</a:t>
            </a:r>
            <a:r>
              <a:rPr lang="es-ES" sz="750" b="1" spc="12" dirty="0">
                <a:latin typeface="Helvetica World" panose="020B0500040000020004" pitchFamily="34" charset="0"/>
                <a:cs typeface="Helvetica World" panose="020B0500040000020004" pitchFamily="34" charset="0"/>
              </a:rPr>
              <a:t> Table 2</a:t>
            </a:r>
            <a:r>
              <a:rPr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. </a:t>
            </a:r>
            <a:r>
              <a:rPr lang="en-US" sz="750" b="1" spc="4" dirty="0">
                <a:latin typeface="Helvetica World" panose="020B0500040000020004" pitchFamily="34" charset="0"/>
                <a:cs typeface="Helvetica World" panose="020B0500040000020004" pitchFamily="34" charset="0"/>
              </a:rPr>
              <a:t>Explanation of cephalometric measurements.</a:t>
            </a:r>
            <a:endParaRPr sz="750" dirty="0">
              <a:latin typeface="Helvetica World" panose="020B0500040000020004" pitchFamily="34" charset="0"/>
              <a:cs typeface="Helvetica World" panose="020B05000400000200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5492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16</TotalTime>
  <Words>3036</Words>
  <Application>Microsoft Office PowerPoint</Application>
  <PresentationFormat>A4 (210 x 297 mm)</PresentationFormat>
  <Paragraphs>401</Paragraphs>
  <Slides>3</Slides>
  <Notes>3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Helvetica World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ejandro Iglesias Linares</dc:creator>
  <cp:lastModifiedBy>Alejandro Iglesias Linares</cp:lastModifiedBy>
  <cp:revision>85</cp:revision>
  <dcterms:created xsi:type="dcterms:W3CDTF">2018-03-20T16:49:51Z</dcterms:created>
  <dcterms:modified xsi:type="dcterms:W3CDTF">2020-09-21T07:22:02Z</dcterms:modified>
</cp:coreProperties>
</file>